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1" autoAdjust="0"/>
    <p:restoredTop sz="95398"/>
  </p:normalViewPr>
  <p:slideViewPr>
    <p:cSldViewPr snapToGrid="0">
      <p:cViewPr varScale="1">
        <p:scale>
          <a:sx n="134" d="100"/>
          <a:sy n="134" d="100"/>
        </p:scale>
        <p:origin x="18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98AF4-C2DE-4087-8142-FC222B25458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BF9-5B7E-4494-80D0-530454C0F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886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98AF4-C2DE-4087-8142-FC222B25458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BF9-5B7E-4494-80D0-530454C0F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007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98AF4-C2DE-4087-8142-FC222B25458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BF9-5B7E-4494-80D0-530454C0F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999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98AF4-C2DE-4087-8142-FC222B25458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BF9-5B7E-4494-80D0-530454C0F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738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98AF4-C2DE-4087-8142-FC222B25458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BF9-5B7E-4494-80D0-530454C0F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5988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98AF4-C2DE-4087-8142-FC222B25458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BF9-5B7E-4494-80D0-530454C0F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3798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98AF4-C2DE-4087-8142-FC222B25458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BF9-5B7E-4494-80D0-530454C0F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9337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98AF4-C2DE-4087-8142-FC222B25458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BF9-5B7E-4494-80D0-530454C0F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551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98AF4-C2DE-4087-8142-FC222B25458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BF9-5B7E-4494-80D0-530454C0F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268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98AF4-C2DE-4087-8142-FC222B25458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BF9-5B7E-4494-80D0-530454C0F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507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998AF4-C2DE-4087-8142-FC222B25458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8ABF9-5B7E-4494-80D0-530454C0F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6071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998AF4-C2DE-4087-8142-FC222B25458E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58ABF9-5B7E-4494-80D0-530454C0F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144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8C6677E-5FA0-4CD0-8AB0-507DBFC12A66}"/>
              </a:ext>
            </a:extLst>
          </p:cNvPr>
          <p:cNvGrpSpPr/>
          <p:nvPr/>
        </p:nvGrpSpPr>
        <p:grpSpPr>
          <a:xfrm>
            <a:off x="790575" y="588436"/>
            <a:ext cx="7562850" cy="4612213"/>
            <a:chOff x="1413062" y="1859028"/>
            <a:chExt cx="5974643" cy="3108960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DB36B461-6B7A-452A-A509-3D714378DFBA}"/>
                </a:ext>
              </a:extLst>
            </p:cNvPr>
            <p:cNvGrpSpPr/>
            <p:nvPr/>
          </p:nvGrpSpPr>
          <p:grpSpPr>
            <a:xfrm>
              <a:off x="1413062" y="1859028"/>
              <a:ext cx="3012649" cy="3108960"/>
              <a:chOff x="3086700" y="211531"/>
              <a:chExt cx="3012649" cy="3108960"/>
            </a:xfrm>
          </p:grpSpPr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CA939623-997B-4FCD-85E3-73BD4936DBB0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296999" y="211531"/>
                <a:ext cx="2802350" cy="3108960"/>
                <a:chOff x="1115775" y="600000"/>
                <a:chExt cx="2550000" cy="2829000"/>
              </a:xfrm>
            </p:grpSpPr>
            <p:pic>
              <p:nvPicPr>
                <p:cNvPr id="7" name="Picture 6">
                  <a:extLst>
                    <a:ext uri="{FF2B5EF4-FFF2-40B4-BE49-F238E27FC236}">
                      <a16:creationId xmlns:a16="http://schemas.microsoft.com/office/drawing/2014/main" id="{6FAC951B-68C1-48D5-BDD5-00D8BDF9008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15775" y="6000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4776B1F5-1D27-48CB-89C7-5C3BE3CB061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15775" y="13050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0F0A76A2-047C-4947-A683-2B381A9041D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15775" y="20100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id="{0910D81E-7561-48E5-AB23-B11BD666B92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15775" y="2724000"/>
                  <a:ext cx="2550000" cy="705000"/>
                </a:xfrm>
                <a:prstGeom prst="rect">
                  <a:avLst/>
                </a:prstGeom>
              </p:spPr>
            </p:pic>
          </p:grp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792111BC-151A-405D-BE31-BAFE128C5B97}"/>
                  </a:ext>
                </a:extLst>
              </p:cNvPr>
              <p:cNvSpPr txBox="1"/>
              <p:nvPr/>
            </p:nvSpPr>
            <p:spPr>
              <a:xfrm>
                <a:off x="3086700" y="278201"/>
                <a:ext cx="4286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FCF4B8A8-82FC-44DF-974D-0CB255838DD6}"/>
                </a:ext>
              </a:extLst>
            </p:cNvPr>
            <p:cNvGrpSpPr/>
            <p:nvPr/>
          </p:nvGrpSpPr>
          <p:grpSpPr>
            <a:xfrm>
              <a:off x="4425711" y="1915294"/>
              <a:ext cx="2961994" cy="3017520"/>
              <a:chOff x="3082686" y="3429000"/>
              <a:chExt cx="2961994" cy="3017520"/>
            </a:xfrm>
          </p:grpSpPr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13FC3A17-9931-4B43-8161-2D8D928238F8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296999" y="3429000"/>
                <a:ext cx="2747681" cy="3017520"/>
                <a:chOff x="5173425" y="600000"/>
                <a:chExt cx="2550000" cy="2800425"/>
              </a:xfrm>
            </p:grpSpPr>
            <p:pic>
              <p:nvPicPr>
                <p:cNvPr id="16" name="Picture 15">
                  <a:extLst>
                    <a:ext uri="{FF2B5EF4-FFF2-40B4-BE49-F238E27FC236}">
                      <a16:creationId xmlns:a16="http://schemas.microsoft.com/office/drawing/2014/main" id="{A04E399A-8DC8-46E6-A3B0-DED3FA4F11E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73425" y="6000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8" name="Picture 17">
                  <a:extLst>
                    <a:ext uri="{FF2B5EF4-FFF2-40B4-BE49-F238E27FC236}">
                      <a16:creationId xmlns:a16="http://schemas.microsoft.com/office/drawing/2014/main" id="{20D4F77B-50E1-4922-BA23-D14626DBFDE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73425" y="1285425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20" name="Picture 19">
                  <a:extLst>
                    <a:ext uri="{FF2B5EF4-FFF2-40B4-BE49-F238E27FC236}">
                      <a16:creationId xmlns:a16="http://schemas.microsoft.com/office/drawing/2014/main" id="{1AC8E45F-2818-4A1B-8B35-8F84625342D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73425" y="1990425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22" name="Picture 21">
                  <a:extLst>
                    <a:ext uri="{FF2B5EF4-FFF2-40B4-BE49-F238E27FC236}">
                      <a16:creationId xmlns:a16="http://schemas.microsoft.com/office/drawing/2014/main" id="{D29C4ECA-9A1E-45F5-8E9D-82A6467A3BD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73425" y="2695425"/>
                  <a:ext cx="2550000" cy="705000"/>
                </a:xfrm>
                <a:prstGeom prst="rect">
                  <a:avLst/>
                </a:prstGeom>
              </p:spPr>
            </p:pic>
          </p:grp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74339F73-62E7-4997-899B-DFA399B71245}"/>
                  </a:ext>
                </a:extLst>
              </p:cNvPr>
              <p:cNvSpPr txBox="1"/>
              <p:nvPr/>
            </p:nvSpPr>
            <p:spPr>
              <a:xfrm>
                <a:off x="3082686" y="3505105"/>
                <a:ext cx="4286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</p:grp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419F6B7B-52DE-4F7D-B833-850FD9D70C9D}"/>
              </a:ext>
            </a:extLst>
          </p:cNvPr>
          <p:cNvSpPr txBox="1"/>
          <p:nvPr/>
        </p:nvSpPr>
        <p:spPr>
          <a:xfrm>
            <a:off x="1537783" y="5451028"/>
            <a:ext cx="6423133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 Fig. PpSP30 nucleotide and amino acid variation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blo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lustrating the relative frequencies of nucleotide polymorphisms in wild caugh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apatas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s from PPAW, PPJM, and PPJS. (B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blo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lustrating the relative frequencies of amino acid polymorphisms in wild caugh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apatas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s from PPAW, PPJM, and PPJS.</a:t>
            </a:r>
          </a:p>
          <a:p>
            <a:pPr algn="just"/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3614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5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te Flanley</dc:creator>
  <cp:lastModifiedBy>Cate Flanley</cp:lastModifiedBy>
  <cp:revision>3</cp:revision>
  <dcterms:created xsi:type="dcterms:W3CDTF">2019-01-18T03:09:40Z</dcterms:created>
  <dcterms:modified xsi:type="dcterms:W3CDTF">2020-06-21T17:45:00Z</dcterms:modified>
</cp:coreProperties>
</file>